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9" d="100"/>
          <a:sy n="69" d="100"/>
        </p:scale>
        <p:origin x="75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E8BE78-2B72-4232-A00F-7F08A82BF0C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C8C5FAC-EE74-413E-93F9-42C0498467A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F2528F-24B9-401F-894C-E75B4375F0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A1FFF-37E7-44C6-BB54-36C454546EE6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A57682-6338-4312-9764-AD66D2D9C5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19B049-778F-4718-9468-1F6BE68F07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F92DF-4ED8-4699-8515-0C0766178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9055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BACB7F-B76A-4F06-8632-131C812B52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70596E5-349D-42E1-93FB-F3E39A7A54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BB2E6D-FFE2-4525-ABEF-9EA163B12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A1FFF-37E7-44C6-BB54-36C454546EE6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3C16F2-B7B7-4289-B083-FE245950C7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EDE34F-75CC-418C-AABD-95553CE0AB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F92DF-4ED8-4699-8515-0C0766178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8386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C7427F1-B893-4E9C-BBE7-ACD76486ABC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3129596-4FA9-4C87-8549-1531991B67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2EC563-3D5F-44DA-B14B-49958393B5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A1FFF-37E7-44C6-BB54-36C454546EE6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9C8950-FD43-4D01-8786-203294454D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C4993E-AAAB-48C8-AC95-F423BEFFDE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F92DF-4ED8-4699-8515-0C0766178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5398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D7EDA6-EBB5-4C4E-B1A4-95277F2313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D46DE81-0371-4C2E-B6DD-2C5C282CCC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947780-40BA-4F05-957B-8E7C2B432E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A1FFF-37E7-44C6-BB54-36C454546EE6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80F0BB-4A55-47DE-A5AB-88FBE68335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7CE11B-0AD5-4FA5-8FAF-6FB6043857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F92DF-4ED8-4699-8515-0C0766178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13979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DFFDBC-1252-438D-BE6F-1EEFE9914F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03C706-2827-4BD8-9C77-C75F00ADCD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1EE0E4-EA74-4DB1-AD55-5BC416BB00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A1FFF-37E7-44C6-BB54-36C454546EE6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187DAF-F2CB-4E60-A14D-7FA3975329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EC5809-4127-471D-9925-324ECEE7D7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F92DF-4ED8-4699-8515-0C0766178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92077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1EF3E8-9501-4BB8-806A-E797639FBB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50A406-34C2-4AC6-8980-74C2B2D211E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67FB9D-496B-459E-B56D-BB9D8DFF06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89152D-A188-4698-8DB8-61A317951F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A1FFF-37E7-44C6-BB54-36C454546EE6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C2A281-0907-406B-B216-D3DD1D8A1B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7343C8-127C-486B-8DC7-D683FD3F8C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F92DF-4ED8-4699-8515-0C0766178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87301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0A5C4A-D271-46CB-B46E-08D671D545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A3D70B-C71F-404B-93B2-A2BFB98526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8958EA2-311C-46C4-9C38-E7BF77693FA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3A2D038-8DAD-43A2-8F27-0793A11F234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A593BEB-E0B3-4437-B321-20D2DC49248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69800C2-B9D4-4D23-9FE6-FBF5629796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A1FFF-37E7-44C6-BB54-36C454546EE6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D74F54B-E546-4866-B310-5240C3438D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C4501A3-189A-495D-B230-D43686C24A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F92DF-4ED8-4699-8515-0C0766178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0647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517076-F806-46AB-9A68-6F3DC4E8D4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1D6B1A7-ADD3-4785-AF28-8FC282CB78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A1FFF-37E7-44C6-BB54-36C454546EE6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2E2DA7D-98E6-4DA9-A854-23BD965994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7298AE7-8D8B-4D73-A5E5-4D202F662C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F92DF-4ED8-4699-8515-0C0766178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54080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BF513CC-068D-40D8-A180-1F0C355F1C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A1FFF-37E7-44C6-BB54-36C454546EE6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5BCB61E-EBBA-4124-8E67-5DEECCD465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DB52155-6796-4CD6-88D1-1B094C745F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F92DF-4ED8-4699-8515-0C0766178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71963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CBF02C-05D2-485E-AA77-C68FD7AD70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610666-2A2B-4A93-A74B-4000AA1BA11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5C1D7A8-3B70-4D00-A1B5-617C08F1DF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3B8607A-2973-4A7D-9E21-E1AC35938F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A1FFF-37E7-44C6-BB54-36C454546EE6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FE7D9A-225B-421C-A1AA-CED5E8026E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52F855-066B-4ACA-A036-FDB06A18A5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F92DF-4ED8-4699-8515-0C0766178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88777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33C247-F876-4CEE-8C82-1CEC7A3360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19B9BEC-F761-44BC-B28A-2C2E1CC3DBF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76F14F7-8639-4411-92C3-C988CFCB3E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51FABF-B3AB-46E2-A0D2-BBA7D7B5AF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9A1FFF-37E7-44C6-BB54-36C454546EE6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4225D33-FA91-4284-8D91-9C041963E2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219B3A-FC97-4CC5-B458-AE4FD58AD2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F92DF-4ED8-4699-8515-0C0766178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19951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722D2B4-3EEE-4665-B340-907570094C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F56F27-B912-4307-A388-99D39858B4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BCD869-5CBF-4375-BB9B-21B1A24FC6F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9A1FFF-37E7-44C6-BB54-36C454546EE6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D30FC2-30A2-4F7C-AAF8-EA6600ED29B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3D4BC1-EDE0-4E4E-861D-92E422CCB1E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8F92DF-4ED8-4699-8515-0C0766178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62872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, map&#10;&#10;Description automatically generated">
            <a:extLst>
              <a:ext uri="{FF2B5EF4-FFF2-40B4-BE49-F238E27FC236}">
                <a16:creationId xmlns:a16="http://schemas.microsoft.com/office/drawing/2014/main" id="{A06A2EC7-AB5B-4991-97E7-45610C81827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5685" y="0"/>
            <a:ext cx="10120630" cy="6858000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EA5BD272-82DE-413F-9093-781774DE5022}"/>
              </a:ext>
            </a:extLst>
          </p:cNvPr>
          <p:cNvSpPr/>
          <p:nvPr/>
        </p:nvSpPr>
        <p:spPr>
          <a:xfrm>
            <a:off x="604191" y="528843"/>
            <a:ext cx="16248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upp-Figure-1a</a:t>
            </a:r>
          </a:p>
        </p:txBody>
      </p:sp>
    </p:spTree>
    <p:extLst>
      <p:ext uri="{BB962C8B-B14F-4D97-AF65-F5344CB8AC3E}">
        <p14:creationId xmlns:p14="http://schemas.microsoft.com/office/powerpoint/2010/main" val="26597738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412A7401-25EB-4CA2-B3C3-BA3DA8F26D73}"/>
              </a:ext>
            </a:extLst>
          </p:cNvPr>
          <p:cNvGrpSpPr/>
          <p:nvPr/>
        </p:nvGrpSpPr>
        <p:grpSpPr>
          <a:xfrm>
            <a:off x="389205" y="1343891"/>
            <a:ext cx="12313923" cy="4585820"/>
            <a:chOff x="-727172" y="958137"/>
            <a:chExt cx="14291407" cy="4823729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BB094550-44EB-4857-B572-EB88D2CEFFBA}"/>
                </a:ext>
              </a:extLst>
            </p:cNvPr>
            <p:cNvSpPr txBox="1"/>
            <p:nvPr/>
          </p:nvSpPr>
          <p:spPr>
            <a:xfrm>
              <a:off x="-727172" y="5427982"/>
              <a:ext cx="6666262" cy="2913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dirty="0">
                  <a:latin typeface="Arial" panose="020B0604020202020204" pitchFamily="34" charset="0"/>
                  <a:cs typeface="Arial" panose="020B0604020202020204" pitchFamily="34" charset="0"/>
                </a:rPr>
                <a:t>pSACas9 Construct -with the gRNA sequence “CCACAGTGGGGCCACTAGGGA”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ECB753B6-3217-444F-93CD-59982A0E9E74}"/>
                </a:ext>
              </a:extLst>
            </p:cNvPr>
            <p:cNvGrpSpPr/>
            <p:nvPr/>
          </p:nvGrpSpPr>
          <p:grpSpPr>
            <a:xfrm>
              <a:off x="6673797" y="958137"/>
              <a:ext cx="6890438" cy="4823729"/>
              <a:chOff x="7152601" y="1112484"/>
              <a:chExt cx="6570307" cy="4197134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AF31D444-7167-42B1-AC43-1DEE74EB894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r="18711" b="3798"/>
              <a:stretch/>
            </p:blipFill>
            <p:spPr>
              <a:xfrm>
                <a:off x="7215611" y="1112484"/>
                <a:ext cx="5353311" cy="3834824"/>
              </a:xfrm>
              <a:prstGeom prst="rect">
                <a:avLst/>
              </a:prstGeom>
            </p:spPr>
          </p:pic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3FCFFF34-CDA2-4F62-A1CE-F09F327546DE}"/>
                  </a:ext>
                </a:extLst>
              </p:cNvPr>
              <p:cNvSpPr txBox="1"/>
              <p:nvPr/>
            </p:nvSpPr>
            <p:spPr>
              <a:xfrm>
                <a:off x="7152601" y="5056097"/>
                <a:ext cx="6570307" cy="2535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SP Cas9 Construct gRNA sequence “GGGGCCACTAGGGACAGGAT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86BCF3E6-85DE-4011-81AD-82BD698E0D0D}"/>
              </a:ext>
            </a:extLst>
          </p:cNvPr>
          <p:cNvSpPr txBox="1"/>
          <p:nvPr/>
        </p:nvSpPr>
        <p:spPr>
          <a:xfrm>
            <a:off x="95250" y="4602"/>
            <a:ext cx="238471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Supp-Figure-1b</a:t>
            </a:r>
          </a:p>
          <a:p>
            <a:endParaRPr lang="en-US" sz="2000" dirty="0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AFD29612-9876-405A-9DF5-671AD3729F3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8863" y="928287"/>
            <a:ext cx="5564371" cy="4605562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7474AB25-05F4-4D69-B3EF-CE798009270C}"/>
              </a:ext>
            </a:extLst>
          </p:cNvPr>
          <p:cNvSpPr/>
          <p:nvPr/>
        </p:nvSpPr>
        <p:spPr>
          <a:xfrm>
            <a:off x="4715613" y="0"/>
            <a:ext cx="208172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gRNA-Cas9 Vectors</a:t>
            </a:r>
          </a:p>
        </p:txBody>
      </p:sp>
    </p:spTree>
    <p:extLst>
      <p:ext uri="{BB962C8B-B14F-4D97-AF65-F5344CB8AC3E}">
        <p14:creationId xmlns:p14="http://schemas.microsoft.com/office/powerpoint/2010/main" val="36448603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1</Words>
  <Application>Microsoft Office PowerPoint</Application>
  <PresentationFormat>Widescreen</PresentationFormat>
  <Paragraphs>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al Madhusudana Girija</dc:creator>
  <cp:lastModifiedBy>Sanal Madhusudana Girija</cp:lastModifiedBy>
  <cp:revision>4</cp:revision>
  <dcterms:created xsi:type="dcterms:W3CDTF">2020-07-17T10:22:20Z</dcterms:created>
  <dcterms:modified xsi:type="dcterms:W3CDTF">2020-07-17T10:25:24Z</dcterms:modified>
</cp:coreProperties>
</file>